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olger Unger" initials="HU" lastIdx="11" clrIdx="0"/>
  <p:cmAuthor id="2" name="Madi Njie" initials="MN" lastIdx="5" clrIdx="1">
    <p:extLst>
      <p:ext uri="{19B8F6BF-5375-455C-9EA6-DF929625EA0E}">
        <p15:presenceInfo xmlns:p15="http://schemas.microsoft.com/office/powerpoint/2012/main" userId="S-1-5-21-2078795561-4233005657-3261906462-420027" providerId="AD"/>
      </p:ext>
    </p:extLst>
  </p:cmAuthor>
  <p:cmAuthor id="3" name="bkhrhome" initials="b" lastIdx="2" clrIdx="2">
    <p:extLst>
      <p:ext uri="{19B8F6BF-5375-455C-9EA6-DF929625EA0E}">
        <p15:presenceInfo xmlns:p15="http://schemas.microsoft.com/office/powerpoint/2012/main" userId="bkhrhom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19" autoAdjust="0"/>
    <p:restoredTop sz="94660"/>
  </p:normalViewPr>
  <p:slideViewPr>
    <p:cSldViewPr snapToGrid="0">
      <p:cViewPr varScale="1">
        <p:scale>
          <a:sx n="72" d="100"/>
          <a:sy n="72" d="100"/>
        </p:scale>
        <p:origin x="95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23262B-43B4-4F5F-B8B0-762709D5C8EC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08D973-1153-4E4B-867F-1B7C3D9AD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8450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9E156-35F4-432B-99CA-72312A1A1A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2FA4F9-0A71-4B4E-B0C2-6AC56266E9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A63AC-D4A6-4E29-B21C-B83B3D7AE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DE09F0-603D-4AE8-BF0C-09E303D07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138981-CD8E-4403-8B9D-10FFB4433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38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F25C1-BDA4-4D9B-9FEF-2BBBB3BF2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D0E4D7-9D79-4A6A-BB5E-33106EE0F4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731355-8432-4D28-A236-3773258C5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194DC9-CF82-4B91-8FB0-DE6BABE23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A1452-1729-4084-B47B-25A2151E0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820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D06C38-8E7B-43E3-9A1D-018F04CB75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746B77-596E-4E56-999E-94DF3D8877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536E5A-B726-487F-B0A8-EA85A4EF7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8005A-4DB6-4CFC-945C-3BD25CCE6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38405-C63A-42AE-81ED-24A082B11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122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62DBD-DE6D-4FBF-89C3-CD3E114C99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3345E1-588B-4CE4-B81F-343FB6855E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33B4E5-F8D5-490B-8BFF-B75D400CB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063A8-1963-4953-871F-64F472666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AF604D-4B47-402B-9476-0F1107EA8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694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80652E-06A4-4740-95BA-3530944025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884C78-680D-44CB-A7BA-CFE8F4493A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129C99-3576-44CD-A6AF-1F02BC578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8E565-7CB8-4E64-B78D-F0CBBA94E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20306-1353-4382-A573-1CAA9C50A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43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EA7EED-EE1C-44F8-BDCE-41217828E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D6D74F-741C-4424-B6F6-7972249813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DE9CE2-AC44-4BD1-A110-E060882D9A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94B37A-F528-44EB-B81E-8D5683908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3617E-8FF9-448A-ADE1-491FAF4C2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75FAC7-BD57-4547-97E6-C5374A068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76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D19E3-24BE-450E-BEB8-D666382BBE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7E105B-92A9-4515-A320-2496B03B33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089639-20CF-4997-8FD9-E2FEC193F3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749358-DAAD-4019-87EA-9CFC558E32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1BF679-ED35-4DD0-81D7-021AD6213C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AA531B-EF2C-43B6-B3CC-7504F16FD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2D669F-47AE-4677-981D-1352554E5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EEA60E-BBC6-4FB3-8570-291B50B84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22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AF2B5-DB08-4A25-A62A-EC0F68F562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0B312A-F91D-4FDE-9B07-74D4E6D8D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DD4FD6-14A4-42EA-9757-88DAD1240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EE7267-EFFE-4A82-926A-DC461461E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8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E79810-7AF7-46E1-B0F2-AA0799194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C32C4C-7069-4770-9263-2B434F6B8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A7645C-C621-417B-B43F-89A2ACFD2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012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D71C4A-63CE-49D2-8CE0-A8EEEB162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4D545B-92AB-4588-9A12-166505CE00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854C0F-5FD2-42A2-936B-27824F1C90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05AD60-637A-4C20-9C7C-5DFE589F7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982D5D-A5C5-4E23-BED2-E5FD3D478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6218B4-F054-4AAF-BE27-2FF051022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465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D227B2-AEFA-4D1A-842D-101EF6E0D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2A6EEE-6EC1-4210-B1DC-DA758E5C2D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14A7AF-1CD2-47A0-97F6-918B4914A6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887EB4-B4DE-4EAD-BD55-2DEE7608BD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B64865-7956-4BBA-BAB3-121FECAC7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423FD9-266B-4A79-9E7F-89AD9D563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519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768024-D601-4C5A-92D1-9790CB5EB6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195474-9B38-4C25-84D1-7C29E1835B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A75CB-9138-49C7-A93A-D826E7BB19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EE2A7-019E-4EE9-8D80-92DE1C4036B0}" type="datetimeFigureOut">
              <a:rPr lang="en-US" smtClean="0"/>
              <a:t>4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46D010-CA12-4EC3-8614-18A4BF9D93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C76DA5-2D4A-4BB3-82FF-1B7C5551E1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A1357-830F-4422-BC02-836CF6964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008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584F557-D531-47E7-8BCE-6A66BC55C6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1104490"/>
              </p:ext>
            </p:extLst>
          </p:nvPr>
        </p:nvGraphicFramePr>
        <p:xfrm>
          <a:off x="1717021" y="192717"/>
          <a:ext cx="4060825" cy="2662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Prism 8" r:id="rId3" imgW="4061611" imgH="2661899" progId="Prism8.Document">
                  <p:embed/>
                </p:oleObj>
              </mc:Choice>
              <mc:Fallback>
                <p:oleObj name="Prism 8" r:id="rId3" imgW="4061611" imgH="2661899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584F557-D531-47E7-8BCE-6A66BC55C6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17021" y="192717"/>
                        <a:ext cx="4060825" cy="2662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28A8D3A-9A44-4F87-B0AC-381A6C6C11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8699061"/>
              </p:ext>
            </p:extLst>
          </p:nvPr>
        </p:nvGraphicFramePr>
        <p:xfrm>
          <a:off x="5585479" y="173668"/>
          <a:ext cx="4065587" cy="2662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Prism 8" r:id="rId5" imgW="4065932" imgH="2661899" progId="Prism8.Document">
                  <p:embed/>
                </p:oleObj>
              </mc:Choice>
              <mc:Fallback>
                <p:oleObj name="Prism 8" r:id="rId5" imgW="4065932" imgH="2661899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28A8D3A-9A44-4F87-B0AC-381A6C6C11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585479" y="173668"/>
                        <a:ext cx="4065587" cy="2662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95CFCFA-62AB-4B0A-A789-2395AD1483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64619"/>
              </p:ext>
            </p:extLst>
          </p:nvPr>
        </p:nvGraphicFramePr>
        <p:xfrm>
          <a:off x="5585479" y="3021804"/>
          <a:ext cx="4889500" cy="278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name="Prism 8" r:id="rId7" imgW="4889202" imgH="2781109" progId="Prism8.Document">
                  <p:embed/>
                </p:oleObj>
              </mc:Choice>
              <mc:Fallback>
                <p:oleObj name="Prism 8" r:id="rId7" imgW="4889202" imgH="2781109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95CFCFA-62AB-4B0A-A789-2395AD1483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85479" y="3021804"/>
                        <a:ext cx="4889500" cy="2781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C45A7A71-845D-4760-93C6-C575A59F55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8777253"/>
              </p:ext>
            </p:extLst>
          </p:nvPr>
        </p:nvGraphicFramePr>
        <p:xfrm>
          <a:off x="1717021" y="3150393"/>
          <a:ext cx="4060825" cy="2662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1" name="Prism 8" r:id="rId9" imgW="4061611" imgH="2661899" progId="Prism8.Document">
                  <p:embed/>
                </p:oleObj>
              </mc:Choice>
              <mc:Fallback>
                <p:oleObj name="Prism 8" r:id="rId9" imgW="4061611" imgH="2661899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C45A7A71-845D-4760-93C6-C575A59F55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717021" y="3150393"/>
                        <a:ext cx="4060825" cy="2662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14586534-5F88-4167-8467-018797D7F89E}"/>
              </a:ext>
            </a:extLst>
          </p:cNvPr>
          <p:cNvSpPr/>
          <p:nvPr/>
        </p:nvSpPr>
        <p:spPr>
          <a:xfrm>
            <a:off x="1717021" y="5931693"/>
            <a:ext cx="911700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1 Fig. Effect of anticoagulant (EDTA and Heparin) on PBMC cytokine secretion.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Blood collected from 4 Australian donors was divided between the two anticoagulants (EDTA and Heparin). PBMC were isolated and stimulated fresh with either P6A1,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uRBC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or PHA for 48 hours. Cytokine levels in the supernatants were analysed by CBA.</a:t>
            </a:r>
          </a:p>
        </p:txBody>
      </p:sp>
    </p:spTree>
    <p:extLst>
      <p:ext uri="{BB962C8B-B14F-4D97-AF65-F5344CB8AC3E}">
        <p14:creationId xmlns:p14="http://schemas.microsoft.com/office/powerpoint/2010/main" val="1214551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9</TotalTime>
  <Words>6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i Njie</dc:creator>
  <cp:lastModifiedBy>Ali Haghiri</cp:lastModifiedBy>
  <cp:revision>33</cp:revision>
  <dcterms:created xsi:type="dcterms:W3CDTF">2019-04-11T06:33:15Z</dcterms:created>
  <dcterms:modified xsi:type="dcterms:W3CDTF">2020-04-04T13:31:46Z</dcterms:modified>
</cp:coreProperties>
</file>